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5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DCF7C29B-23F4-4C4A-A8FC-1D508BBAF54D}"/>
    <pc:docChg chg="undo custSel modSld">
      <pc:chgData name="Laycock, Joseph" userId="c4bfcbf4-3ccc-440e-b317-559baf184f0d" providerId="ADAL" clId="{DCF7C29B-23F4-4C4A-A8FC-1D508BBAF54D}" dt="2025-02-13T21:53:24.933" v="92" actId="1038"/>
      <pc:docMkLst>
        <pc:docMk/>
      </pc:docMkLst>
      <pc:sldChg chg="modSp mod">
        <pc:chgData name="Laycock, Joseph" userId="c4bfcbf4-3ccc-440e-b317-559baf184f0d" providerId="ADAL" clId="{DCF7C29B-23F4-4C4A-A8FC-1D508BBAF54D}" dt="2025-02-13T21:53:24.933" v="92" actId="1038"/>
        <pc:sldMkLst>
          <pc:docMk/>
          <pc:sldMk cId="4048924459" sldId="272"/>
        </pc:sldMkLst>
        <pc:spChg chg="mod">
          <ac:chgData name="Laycock, Joseph" userId="c4bfcbf4-3ccc-440e-b317-559baf184f0d" providerId="ADAL" clId="{DCF7C29B-23F4-4C4A-A8FC-1D508BBAF54D}" dt="2025-02-13T21:52:19.211" v="70" actId="948"/>
          <ac:spMkLst>
            <pc:docMk/>
            <pc:sldMk cId="4048924459" sldId="272"/>
            <ac:spMk id="4" creationId="{767110FE-CFDF-BF93-A923-3253F9E75B29}"/>
          </ac:spMkLst>
        </pc:spChg>
        <pc:spChg chg="mod">
          <ac:chgData name="Laycock, Joseph" userId="c4bfcbf4-3ccc-440e-b317-559baf184f0d" providerId="ADAL" clId="{DCF7C29B-23F4-4C4A-A8FC-1D508BBAF54D}" dt="2025-02-13T21:52:42.255" v="84" actId="1038"/>
          <ac:spMkLst>
            <pc:docMk/>
            <pc:sldMk cId="4048924459" sldId="272"/>
            <ac:spMk id="6" creationId="{B8C3F199-12A1-FD9E-3F46-B336BCE4A5C9}"/>
          </ac:spMkLst>
        </pc:spChg>
        <pc:spChg chg="mod">
          <ac:chgData name="Laycock, Joseph" userId="c4bfcbf4-3ccc-440e-b317-559baf184f0d" providerId="ADAL" clId="{DCF7C29B-23F4-4C4A-A8FC-1D508BBAF54D}" dt="2025-02-13T21:52:22.958" v="71" actId="1036"/>
          <ac:spMkLst>
            <pc:docMk/>
            <pc:sldMk cId="4048924459" sldId="272"/>
            <ac:spMk id="8" creationId="{A314D33F-1D66-140E-85EC-A4AED9A167F0}"/>
          </ac:spMkLst>
        </pc:spChg>
        <pc:picChg chg="mod">
          <ac:chgData name="Laycock, Joseph" userId="c4bfcbf4-3ccc-440e-b317-559baf184f0d" providerId="ADAL" clId="{DCF7C29B-23F4-4C4A-A8FC-1D508BBAF54D}" dt="2025-02-13T21:53:24.933" v="92" actId="1038"/>
          <ac:picMkLst>
            <pc:docMk/>
            <pc:sldMk cId="4048924459" sldId="272"/>
            <ac:picMk id="9" creationId="{F45DE8FB-EAC4-470C-949C-13F3A73FEF6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8D7AC28-0C09-467E-B921-77B4E48F34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A255B21-309B-431C-9E82-65D015CE6D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A79AA07-1A63-4AB4-BD44-EB43C9FBE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D3C1B50-B117-4C21-A4CD-0097A49FA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8B51A59-A05C-4E2E-AFBB-FED6D2CFD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3839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A56809-0F47-4716-8888-1AA75B2D2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39710E4-B0DF-44BF-9259-C5E85ABE65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4249F6E-5271-439D-922A-0D188623F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937CF73-265F-4E59-8838-11DC16983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59B1B6-742F-40F1-88F1-92321B2B5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590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01F8418-8A6D-45FB-B863-14A02D5627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49FA112-CF7C-497A-B04B-52E7D8188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340EAFA-25A9-4EDB-8289-E9E8D54DC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E4039C8-BC47-4C05-A796-11E532D56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A9F71D-555C-4B26-83A2-10CF34D84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966660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231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060F3B-D33A-4A1C-9524-72FE968EA0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370CA11-4F1C-4156-845E-F4683F1FAB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D1F8D0-26CF-4018-A8C6-6A7B7C14B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35E00B-C305-4927-8DD4-742E35C6A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799EF23-06AE-4E87-B73D-88889C200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216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8205B7-B161-4BDC-8C9D-AD9C5C108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1D68124-9825-483B-AD48-99FE7FC81A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2FFB2F-7DAF-48BD-91F8-F22368A32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11A4EE9-C8E1-461A-8A6D-27F91A186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DB4476-BDD8-43EF-B7DD-312E7E86E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0349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78CF430-D4C4-4943-B1A4-C0AE8DA97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99F6BDF-18DF-4081-96A0-DC2439559E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B17BE1E-AC58-402F-BA24-5350C6106D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EFD0586-DB4E-4342-961D-A15EC18CB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6D11F9D-FF41-4920-8F4C-7480B2ECF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CC0BDD8-B0EE-40FB-B17A-1F710BF2A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3099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7C0D36-0E41-4AD8-934B-88837AB5D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89AD312-833E-4375-8FE3-3C5AB5BFDE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89F67D5-9231-4A9A-A7E1-437A54EFC0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5F0FEE6-2507-4FEB-8587-543303DBE6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CBDCCE8-4479-4FFC-B2CD-E234642968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70EBBD9-7C69-4A8D-A34F-4535B4946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22DD2D6-986C-46CE-92FE-EB9767344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B87CA6B-C5C3-4E88-9B24-813961960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2670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C0568C-79BC-4D1F-9CCC-E9C82CE02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C4C3AA6-012E-43DB-B185-858EF2425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27B01EE-9854-42E0-A33F-5E79BAE15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920338B-0FB5-4332-98F3-5AA741DB6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2170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48CEB78-1DA7-453E-BEB9-CCE28E25E0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30E34EB-1F51-4A5C-A44E-1F33ECD31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42328FE-541D-4AF5-9B7B-7E958B2A17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897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C8DEFF3-1480-43B2-9998-F0CA91DA6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463274B-5EF6-4EEF-AC67-6A3D2BE9ED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DC38DF6-AA87-4653-80BA-4B527BABB0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D3960CE-3D24-4446-AA9C-D9443333A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465965C-FBB2-4186-9313-0A63BB71F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5C4EB03-6761-4CE7-B74B-779AAE046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4532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E4AF1B-AED8-4F1E-BCC1-2C073AFE2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13894EA-E710-4F3B-97DB-718550A4A7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6CA4531-6931-40B1-9EF6-BB74F396CB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7C20374-5E62-4FEC-8452-C40CBF9BD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CFA83A0-DF79-47D9-BFA1-691E08A4E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FF4C79A-6251-433C-A167-B74D81A0E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3994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D799101-5D4C-4796-9AE9-DA14CC911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AD07C70-4F6F-4681-9635-A8B65D592B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DBEF2B-75A7-44DB-9498-45FC6DA570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C04DB-87FD-44D5-AA05-BA3A8AC1C2C7}" type="datetimeFigureOut">
              <a:rPr lang="it-IT" smtClean="0"/>
              <a:t>13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9B55734-5A08-4287-B39E-71FB836EE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2A070-E321-43E0-8BCF-F2808AF610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AA298-53FC-4DD2-9386-378F941966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6009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New and old corticosteroid treatments in IgA nephropath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186774" y="1347275"/>
            <a:ext cx="5232951" cy="41703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GB" sz="16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y points</a:t>
            </a:r>
            <a:r>
              <a:rPr lang="en-GB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kern="0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ESTING Trial with  oral methylprednisolone is compared to </a:t>
            </a:r>
            <a:r>
              <a:rPr lang="en-US" sz="1600" kern="0" dirty="0" err="1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EFIgArd</a:t>
            </a:r>
            <a:r>
              <a:rPr lang="en-US" sz="1600" kern="0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rial with enteric release  budesonide</a:t>
            </a:r>
            <a:r>
              <a:rPr lang="it-IT" sz="1600" kern="0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 </a:t>
            </a:r>
            <a:r>
              <a:rPr lang="it-IT" sz="1600" dirty="0">
                <a:solidFill>
                  <a:srgbClr val="0070C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600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Nefecon)</a:t>
            </a: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pt-BR" sz="1600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efecon and methylprednisone showed 40-50% proteinuria reduction with faster effect of methylprednisolone  (3-6 months) versus Nefecon (9 months) and similar effect on renal function decline.</a:t>
            </a: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GB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IGO 2024 under public review considers as a target the reduction of galactose-deficient IgA1 demonstrated for </a:t>
            </a:r>
            <a:r>
              <a:rPr lang="en-GB" sz="16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fecon</a:t>
            </a:r>
            <a:r>
              <a:rPr lang="en-GB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6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fecon</a:t>
            </a:r>
            <a:r>
              <a:rPr lang="en-GB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new disease modifying treatments are expected in children with </a:t>
            </a:r>
            <a:r>
              <a:rPr lang="en-GB" sz="16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endParaRPr lang="en-GB" sz="16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6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079" y="5677750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eruzzi and Coppo,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57151" y="5656944"/>
            <a:ext cx="7391399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S</a:t>
            </a:r>
            <a:r>
              <a:rPr lang="en-US" dirty="0">
                <a:solidFill>
                  <a:schemeClr val="bg1"/>
                </a:solidFill>
              </a:rPr>
              <a:t>ystemic CS are the only treatments approved for children with IgAN, but interest on the intestinal mucosal targeted budesonide is high in the pediatric community</a:t>
            </a:r>
            <a:r>
              <a:rPr lang="en-GB" dirty="0">
                <a:solidFill>
                  <a:schemeClr val="bg1"/>
                </a:solidFill>
              </a:rPr>
              <a:t>. </a:t>
            </a:r>
            <a:r>
              <a:rPr lang="en-US" dirty="0">
                <a:solidFill>
                  <a:schemeClr val="bg1"/>
                </a:solidFill>
              </a:rPr>
              <a:t>A multilevel action is required, directed to simultaneously limit glomerular loss and hyperfiltration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14D33F-1D66-140E-85EC-A4AED9A167F0}"/>
              </a:ext>
            </a:extLst>
          </p:cNvPr>
          <p:cNvSpPr txBox="1"/>
          <p:nvPr/>
        </p:nvSpPr>
        <p:spPr>
          <a:xfrm>
            <a:off x="498873" y="5339642"/>
            <a:ext cx="116919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3969"/>
                </a:solidFill>
              </a:rPr>
              <a:t>Full title: ‘Expected and verified benefits from old and new corticosteroid treatments in IgA Nephropathy:  from trials in adults to new IPNA-KDIGO guidelines’ </a:t>
            </a:r>
            <a:endParaRPr lang="en-GB" sz="1400" dirty="0">
              <a:solidFill>
                <a:srgbClr val="003969"/>
              </a:solidFill>
            </a:endParaRP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F45DE8FB-EAC4-470C-949C-13F3A73FEF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642" b="20047"/>
          <a:stretch/>
        </p:blipFill>
        <p:spPr>
          <a:xfrm>
            <a:off x="5299587" y="1539967"/>
            <a:ext cx="6920764" cy="302808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68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icia Peruzzi</dc:creator>
  <cp:lastModifiedBy>Laycock, Joseph</cp:lastModifiedBy>
  <cp:revision>9</cp:revision>
  <dcterms:created xsi:type="dcterms:W3CDTF">2024-11-21T10:43:09Z</dcterms:created>
  <dcterms:modified xsi:type="dcterms:W3CDTF">2025-02-13T21:53:31Z</dcterms:modified>
</cp:coreProperties>
</file>